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75" r:id="rId2"/>
    <p:sldId id="278" r:id="rId3"/>
    <p:sldId id="279" r:id="rId4"/>
    <p:sldId id="282" r:id="rId5"/>
    <p:sldId id="276" r:id="rId6"/>
    <p:sldId id="277" r:id="rId7"/>
    <p:sldId id="262" r:id="rId8"/>
    <p:sldId id="280" r:id="rId9"/>
    <p:sldId id="281" r:id="rId10"/>
  </p:sldIdLst>
  <p:sldSz cx="6858000" cy="9906000" type="A4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4" pos="1128" userDrawn="1">
          <p15:clr>
            <a:srgbClr val="A4A3A4"/>
          </p15:clr>
        </p15:guide>
        <p15:guide id="5" orient="horz" pos="2256" userDrawn="1">
          <p15:clr>
            <a:srgbClr val="A4A3A4"/>
          </p15:clr>
        </p15:guide>
        <p15:guide id="7" orient="horz" pos="264" userDrawn="1">
          <p15:clr>
            <a:srgbClr val="A4A3A4"/>
          </p15:clr>
        </p15:guide>
        <p15:guide id="8" orient="horz" pos="3552" userDrawn="1">
          <p15:clr>
            <a:srgbClr val="A4A3A4"/>
          </p15:clr>
        </p15:guide>
        <p15:guide id="9" pos="360" userDrawn="1">
          <p15:clr>
            <a:srgbClr val="A4A3A4"/>
          </p15:clr>
        </p15:guide>
        <p15:guide id="10" orient="horz" pos="2784" userDrawn="1">
          <p15:clr>
            <a:srgbClr val="A4A3A4"/>
          </p15:clr>
        </p15:guide>
        <p15:guide id="11" pos="1296" userDrawn="1">
          <p15:clr>
            <a:srgbClr val="A4A3A4"/>
          </p15:clr>
        </p15:guide>
        <p15:guide id="12" orient="horz" pos="528" userDrawn="1">
          <p15:clr>
            <a:srgbClr val="A4A3A4"/>
          </p15:clr>
        </p15:guide>
        <p15:guide id="13" orient="horz" pos="1848" userDrawn="1">
          <p15:clr>
            <a:srgbClr val="A4A3A4"/>
          </p15:clr>
        </p15:guide>
        <p15:guide id="14" orient="horz" pos="696" userDrawn="1">
          <p15:clr>
            <a:srgbClr val="A4A3A4"/>
          </p15:clr>
        </p15:guide>
        <p15:guide id="15" pos="2880" userDrawn="1">
          <p15:clr>
            <a:srgbClr val="A4A3A4"/>
          </p15:clr>
        </p15:guide>
        <p15:guide id="16" orient="horz" pos="1512" userDrawn="1">
          <p15:clr>
            <a:srgbClr val="A4A3A4"/>
          </p15:clr>
        </p15:guide>
        <p15:guide id="17" orient="horz" pos="2736" userDrawn="1">
          <p15:clr>
            <a:srgbClr val="A4A3A4"/>
          </p15:clr>
        </p15:guide>
        <p15:guide id="18" pos="1968" userDrawn="1">
          <p15:clr>
            <a:srgbClr val="A4A3A4"/>
          </p15:clr>
        </p15:guide>
        <p15:guide id="19" pos="3048" userDrawn="1">
          <p15:clr>
            <a:srgbClr val="A4A3A4"/>
          </p15:clr>
        </p15:guide>
        <p15:guide id="20" orient="horz" pos="2880" userDrawn="1">
          <p15:clr>
            <a:srgbClr val="A4A3A4"/>
          </p15:clr>
        </p15:guide>
        <p15:guide id="21" pos="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FDFDF"/>
    <a:srgbClr val="4F81BD"/>
    <a:srgbClr val="B6504D"/>
  </p:clrMru>
  <p:extLst>
    <p:ext uri="{E76CE94A-603C-4142-B9EB-6D1370010A27}">
      <p14:discardImageEditData xmlns:p14="http://schemas.microsoft.com/office/powerpoint/2010/main" val="1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565" autoAdjust="0"/>
    <p:restoredTop sz="94660"/>
  </p:normalViewPr>
  <p:slideViewPr>
    <p:cSldViewPr snapToGrid="0" showGuides="1">
      <p:cViewPr>
        <p:scale>
          <a:sx n="200" d="100"/>
          <a:sy n="200" d="100"/>
        </p:scale>
        <p:origin x="288" y="-5226"/>
      </p:cViewPr>
      <p:guideLst>
        <p:guide pos="1128"/>
        <p:guide orient="horz" pos="2256"/>
        <p:guide orient="horz" pos="264"/>
        <p:guide orient="horz" pos="3552"/>
        <p:guide pos="360"/>
        <p:guide orient="horz" pos="2784"/>
        <p:guide pos="1296"/>
        <p:guide orient="horz" pos="528"/>
        <p:guide orient="horz" pos="1848"/>
        <p:guide orient="horz" pos="696"/>
        <p:guide pos="2880"/>
        <p:guide orient="horz" pos="1512"/>
        <p:guide orient="horz" pos="2736"/>
        <p:guide pos="1968"/>
        <p:guide pos="3048"/>
        <p:guide orient="horz" pos="2880"/>
        <p:guide pos="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60E31-3D8D-4B5B-B15E-662130038D26}" type="datetimeFigureOut">
              <a:rPr lang="de-DE" smtClean="0"/>
              <a:pPr/>
              <a:t>09.1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1C9DA-B745-4425-87AD-C6E71BFB16B1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2864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60E31-3D8D-4B5B-B15E-662130038D26}" type="datetimeFigureOut">
              <a:rPr lang="de-DE" smtClean="0"/>
              <a:pPr/>
              <a:t>09.1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1C9DA-B745-4425-87AD-C6E71BFB16B1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610544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60E31-3D8D-4B5B-B15E-662130038D26}" type="datetimeFigureOut">
              <a:rPr lang="de-DE" smtClean="0"/>
              <a:pPr/>
              <a:t>09.1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1C9DA-B745-4425-87AD-C6E71BFB16B1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21365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60E31-3D8D-4B5B-B15E-662130038D26}" type="datetimeFigureOut">
              <a:rPr lang="de-DE" smtClean="0"/>
              <a:pPr/>
              <a:t>09.1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1C9DA-B745-4425-87AD-C6E71BFB16B1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29706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60E31-3D8D-4B5B-B15E-662130038D26}" type="datetimeFigureOut">
              <a:rPr lang="de-DE" smtClean="0"/>
              <a:pPr/>
              <a:t>09.1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1C9DA-B745-4425-87AD-C6E71BFB16B1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10792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60E31-3D8D-4B5B-B15E-662130038D26}" type="datetimeFigureOut">
              <a:rPr lang="de-DE" smtClean="0"/>
              <a:pPr/>
              <a:t>09.12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1C9DA-B745-4425-87AD-C6E71BFB16B1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056751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60E31-3D8D-4B5B-B15E-662130038D26}" type="datetimeFigureOut">
              <a:rPr lang="de-DE" smtClean="0"/>
              <a:pPr/>
              <a:t>09.12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1C9DA-B745-4425-87AD-C6E71BFB16B1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588051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60E31-3D8D-4B5B-B15E-662130038D26}" type="datetimeFigureOut">
              <a:rPr lang="de-DE" smtClean="0"/>
              <a:pPr/>
              <a:t>09.12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1C9DA-B745-4425-87AD-C6E71BFB16B1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590388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60E31-3D8D-4B5B-B15E-662130038D26}" type="datetimeFigureOut">
              <a:rPr lang="de-DE" smtClean="0"/>
              <a:pPr/>
              <a:t>09.12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1C9DA-B745-4425-87AD-C6E71BFB16B1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80824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60E31-3D8D-4B5B-B15E-662130038D26}" type="datetimeFigureOut">
              <a:rPr lang="de-DE" smtClean="0"/>
              <a:pPr/>
              <a:t>09.12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1C9DA-B745-4425-87AD-C6E71BFB16B1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24786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60E31-3D8D-4B5B-B15E-662130038D26}" type="datetimeFigureOut">
              <a:rPr lang="de-DE" smtClean="0"/>
              <a:pPr/>
              <a:t>09.12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1C9DA-B745-4425-87AD-C6E71BFB16B1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2449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C60E31-3D8D-4B5B-B15E-662130038D26}" type="datetimeFigureOut">
              <a:rPr lang="de-DE" smtClean="0"/>
              <a:pPr/>
              <a:t>09.1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B1C9DA-B745-4425-87AD-C6E71BFB16B1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49686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7" Type="http://schemas.openxmlformats.org/officeDocument/2006/relationships/image" Target="../media/image23.emf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emf"/><Relationship Id="rId5" Type="http://schemas.openxmlformats.org/officeDocument/2006/relationships/image" Target="../media/image21.emf"/><Relationship Id="rId4" Type="http://schemas.openxmlformats.org/officeDocument/2006/relationships/image" Target="../media/image20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7.emf"/><Relationship Id="rId4" Type="http://schemas.openxmlformats.org/officeDocument/2006/relationships/image" Target="../media/image26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emf"/><Relationship Id="rId2" Type="http://schemas.openxmlformats.org/officeDocument/2006/relationships/image" Target="../media/image28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2.emf"/><Relationship Id="rId5" Type="http://schemas.openxmlformats.org/officeDocument/2006/relationships/image" Target="../media/image31.emf"/><Relationship Id="rId4" Type="http://schemas.openxmlformats.org/officeDocument/2006/relationships/image" Target="../media/image30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emf"/><Relationship Id="rId7" Type="http://schemas.openxmlformats.org/officeDocument/2006/relationships/image" Target="../media/image38.emf"/><Relationship Id="rId2" Type="http://schemas.openxmlformats.org/officeDocument/2006/relationships/image" Target="../media/image3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emf"/><Relationship Id="rId5" Type="http://schemas.openxmlformats.org/officeDocument/2006/relationships/image" Target="../media/image36.emf"/><Relationship Id="rId4" Type="http://schemas.openxmlformats.org/officeDocument/2006/relationships/image" Target="../media/image35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jpeg"/><Relationship Id="rId13" Type="http://schemas.openxmlformats.org/officeDocument/2006/relationships/image" Target="../media/image50.jpeg"/><Relationship Id="rId3" Type="http://schemas.openxmlformats.org/officeDocument/2006/relationships/image" Target="../media/image40.jpeg"/><Relationship Id="rId7" Type="http://schemas.openxmlformats.org/officeDocument/2006/relationships/image" Target="../media/image44.jpeg"/><Relationship Id="rId12" Type="http://schemas.openxmlformats.org/officeDocument/2006/relationships/image" Target="../media/image49.jpeg"/><Relationship Id="rId2" Type="http://schemas.openxmlformats.org/officeDocument/2006/relationships/image" Target="../media/image3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3.jpeg"/><Relationship Id="rId11" Type="http://schemas.openxmlformats.org/officeDocument/2006/relationships/image" Target="../media/image48.jpeg"/><Relationship Id="rId5" Type="http://schemas.openxmlformats.org/officeDocument/2006/relationships/image" Target="../media/image42.jpeg"/><Relationship Id="rId15" Type="http://schemas.openxmlformats.org/officeDocument/2006/relationships/image" Target="../media/image52.jpeg"/><Relationship Id="rId10" Type="http://schemas.openxmlformats.org/officeDocument/2006/relationships/image" Target="../media/image47.jpeg"/><Relationship Id="rId4" Type="http://schemas.openxmlformats.org/officeDocument/2006/relationships/image" Target="../media/image41.jpeg"/><Relationship Id="rId9" Type="http://schemas.openxmlformats.org/officeDocument/2006/relationships/image" Target="../media/image46.jpeg"/><Relationship Id="rId14" Type="http://schemas.openxmlformats.org/officeDocument/2006/relationships/image" Target="../media/image5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/>
          <p:cNvSpPr txBox="1"/>
          <p:nvPr/>
        </p:nvSpPr>
        <p:spPr>
          <a:xfrm>
            <a:off x="347615" y="3398520"/>
            <a:ext cx="590840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1.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n-volatile residues (NVRs) obtained after extraction of a whole wheat grain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omogenate</a:t>
            </a:r>
            <a:r>
              <a:rPr lang="de-DE" sz="1000" smtClean="0">
                <a:latin typeface="Arial" panose="020B0604020202020204" pitchFamily="34" charset="0"/>
                <a:cs typeface="Arial" panose="020B0604020202020204" pitchFamily="34" charset="0"/>
              </a:rPr>
              <a:t> (´JB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sano´) with different solvent mixtures. Mean ± standard deviation (n = 3) is shown. 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4810" y="691284"/>
            <a:ext cx="4575643" cy="27392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69040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6132" y="4269332"/>
            <a:ext cx="1807920" cy="108543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24426" y="701907"/>
            <a:ext cx="2062470" cy="1233358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8155" y="690819"/>
            <a:ext cx="2059039" cy="123335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4803" y="1878233"/>
            <a:ext cx="2060411" cy="1233358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15340" y="1881684"/>
            <a:ext cx="2065901" cy="1233358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744540" y="1927779"/>
            <a:ext cx="1752345" cy="1048457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741208" y="3116182"/>
            <a:ext cx="1752345" cy="1048457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509525" y="3052234"/>
            <a:ext cx="2068645" cy="1233358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98285" y="3059958"/>
            <a:ext cx="2075506" cy="1233358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147808" y="63414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516266" y="706040"/>
            <a:ext cx="2059039" cy="1233358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147808" y="1818421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47165" y="299315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47545" y="4177807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42900" y="5509663"/>
            <a:ext cx="622554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2. a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bundance of hydroxycinnamic acid amides [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coumaroyl-hydroxyputrescine (HCAA2), 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de-DE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sinapoylagmatine (HCAA11), 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de-DE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coumaroyl-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de-DE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feruloylspermine (HCAA20)] in whole wheat grain extracts prepared with different solvent mixtures.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ean ± standard deviation (n = 3) is shown. 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bundance of mono- and diglycosylated benzoxazinoids [DIBOA Hex (BX3), DIBOA Hex</a:t>
            </a:r>
            <a:r>
              <a:rPr lang="de-DE" sz="10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BX4)] in whole wheat grain extracts prepared with different solvent mixtures.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ean ± standard deviation (n = 3) is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own. 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Abundance of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i-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riglycosylated hydroquinones [methoxyhydroquinone Hex</a:t>
            </a:r>
            <a:r>
              <a:rPr lang="de-DE" sz="10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HQ4),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ethoxyhydroquinone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ex</a:t>
            </a:r>
            <a:r>
              <a:rPr lang="de-DE" sz="10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HQ2)]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hole wheat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grain extracts prepared with different solvent mixtures. Mean ± standard deviation (n = 3) is shown. 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Abundance of mono- and diglycosylated benzoxazinoids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nd di-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and triglycosylated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ydroquinones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hole wheat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grain extracts prepared with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80% aqueous acetonitrile at different temperatures (22 °C, 75°C).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ean ± standard deviation (n = 3) is show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477876" y="4268581"/>
            <a:ext cx="1807920" cy="10854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30676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3469" y="390070"/>
            <a:ext cx="4575643" cy="2740795"/>
          </a:xfrm>
          <a:prstGeom prst="rect">
            <a:avLst/>
          </a:prstGeom>
        </p:spPr>
      </p:pic>
      <p:sp>
        <p:nvSpPr>
          <p:cNvPr id="34" name="TextBox 33"/>
          <p:cNvSpPr txBox="1"/>
          <p:nvPr/>
        </p:nvSpPr>
        <p:spPr>
          <a:xfrm>
            <a:off x="415196" y="3417957"/>
            <a:ext cx="622554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3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xtraction efficiency dependent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n the number of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xtraction step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 whol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heat grain homogenate was consecutively extracted three times with ethanol/water, 4/1 (v/v) at a solid-to-solvent ratio of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/20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w/v). The resulting extracts were analyzed by LC/MS and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ight abundant metabolite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quantified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tegration of extracted ion chromatograms generated for respective quantifier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ons. Total peak area of three extraction steps was set to 100%.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henylalanine (A22), DIBOA Hex</a:t>
            </a:r>
            <a:r>
              <a:rPr lang="de-DE" sz="10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BX4), 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de-DE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coumaroyl-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de-DE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feruloylspermine (HCAA 20), 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de-DE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sinapoylagmatine (HCAA11),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ethoxyhydroquinone Hex</a:t>
            </a:r>
            <a:r>
              <a:rPr lang="de-DE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(HQ2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, apigenin 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Pent-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Hex (F2), apigenin 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Pent-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Hex-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Sinapoyl (F9), pantothenic acid (V1).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05358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/>
          <p:cNvSpPr txBox="1"/>
          <p:nvPr/>
        </p:nvSpPr>
        <p:spPr>
          <a:xfrm>
            <a:off x="283559" y="8498481"/>
            <a:ext cx="62255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4.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xperimental procedure for extract preparation. 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78766" y="703629"/>
            <a:ext cx="19266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weigh 500 mg into 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5 ml PP-centrifuge tube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91509" y="1740566"/>
            <a:ext cx="11528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) add 500 µL IS Mix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) add 10 mL 80% aq. EtOH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3) vortex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90240" y="2780729"/>
            <a:ext cx="14863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) sonicate (15 min, 22-25 °C)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) shake (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800 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r>
              <a:rPr lang="de-DE" sz="600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,100 min, 22 °C)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3) centrifuge (4696 g, 10 min, 22°C) </a:t>
            </a:r>
          </a:p>
        </p:txBody>
      </p:sp>
      <p:cxnSp>
        <p:nvCxnSpPr>
          <p:cNvPr id="71" name="Straight Arrow Connector 70"/>
          <p:cNvCxnSpPr/>
          <p:nvPr/>
        </p:nvCxnSpPr>
        <p:spPr>
          <a:xfrm>
            <a:off x="1790699" y="690048"/>
            <a:ext cx="0" cy="3513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2" name="Picture 7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4528" y="3150011"/>
            <a:ext cx="294667" cy="720571"/>
          </a:xfrm>
          <a:prstGeom prst="rect">
            <a:avLst/>
          </a:prstGeom>
        </p:spPr>
      </p:pic>
      <p:pic>
        <p:nvPicPr>
          <p:cNvPr id="73" name="Picture 7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3985" y="2089732"/>
            <a:ext cx="294667" cy="720571"/>
          </a:xfrm>
          <a:prstGeom prst="rect">
            <a:avLst/>
          </a:prstGeom>
        </p:spPr>
      </p:pic>
      <p:pic>
        <p:nvPicPr>
          <p:cNvPr id="74" name="Picture 7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6366" y="1021098"/>
            <a:ext cx="293429" cy="720571"/>
          </a:xfrm>
          <a:prstGeom prst="rect">
            <a:avLst/>
          </a:prstGeom>
        </p:spPr>
      </p:pic>
      <p:pic>
        <p:nvPicPr>
          <p:cNvPr id="75" name="Picture 7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2966" y="3636194"/>
            <a:ext cx="307048" cy="747810"/>
          </a:xfrm>
          <a:prstGeom prst="rect">
            <a:avLst/>
          </a:prstGeom>
        </p:spPr>
      </p:pic>
      <p:sp>
        <p:nvSpPr>
          <p:cNvPr id="76" name="TextBox 75"/>
          <p:cNvSpPr txBox="1"/>
          <p:nvPr/>
        </p:nvSpPr>
        <p:spPr>
          <a:xfrm>
            <a:off x="1115541" y="479605"/>
            <a:ext cx="1353022" cy="184666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hole wheat grain homogenate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Straight Arrow Connector 76"/>
          <p:cNvCxnSpPr/>
          <p:nvPr/>
        </p:nvCxnSpPr>
        <p:spPr>
          <a:xfrm>
            <a:off x="1790699" y="1764948"/>
            <a:ext cx="0" cy="3513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Arrow Connector 77"/>
          <p:cNvCxnSpPr/>
          <p:nvPr/>
        </p:nvCxnSpPr>
        <p:spPr>
          <a:xfrm>
            <a:off x="1790699" y="2826178"/>
            <a:ext cx="0" cy="3513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9" name="Picture 7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6375" y="4219441"/>
            <a:ext cx="293429" cy="720571"/>
          </a:xfrm>
          <a:prstGeom prst="rect">
            <a:avLst/>
          </a:prstGeom>
        </p:spPr>
      </p:pic>
      <p:cxnSp>
        <p:nvCxnSpPr>
          <p:cNvPr id="80" name="Straight Arrow Connector 79"/>
          <p:cNvCxnSpPr/>
          <p:nvPr/>
        </p:nvCxnSpPr>
        <p:spPr>
          <a:xfrm>
            <a:off x="1790699" y="3892807"/>
            <a:ext cx="0" cy="3513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80"/>
          <p:cNvSpPr txBox="1"/>
          <p:nvPr/>
        </p:nvSpPr>
        <p:spPr>
          <a:xfrm>
            <a:off x="1952497" y="7229931"/>
            <a:ext cx="1130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ollect supernatant 2 and </a:t>
            </a:r>
          </a:p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ombine with supernatant 1</a:t>
            </a:r>
          </a:p>
        </p:txBody>
      </p:sp>
      <p:pic>
        <p:nvPicPr>
          <p:cNvPr id="82" name="Picture 8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5922" y="5275193"/>
            <a:ext cx="294667" cy="720571"/>
          </a:xfrm>
          <a:prstGeom prst="rect">
            <a:avLst/>
          </a:prstGeom>
        </p:spPr>
      </p:pic>
      <p:sp>
        <p:nvSpPr>
          <p:cNvPr id="83" name="TextBox 82"/>
          <p:cNvSpPr txBox="1"/>
          <p:nvPr/>
        </p:nvSpPr>
        <p:spPr>
          <a:xfrm>
            <a:off x="391509" y="4976850"/>
            <a:ext cx="1152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) add 10 mL 80% aq. EtOH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) vortex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4" name="Picture 8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5921" y="6328518"/>
            <a:ext cx="294667" cy="720571"/>
          </a:xfrm>
          <a:prstGeom prst="rect">
            <a:avLst/>
          </a:prstGeom>
        </p:spPr>
      </p:pic>
      <p:cxnSp>
        <p:nvCxnSpPr>
          <p:cNvPr id="88" name="Straight Arrow Connector 87"/>
          <p:cNvCxnSpPr/>
          <p:nvPr/>
        </p:nvCxnSpPr>
        <p:spPr>
          <a:xfrm>
            <a:off x="1790700" y="4954996"/>
            <a:ext cx="0" cy="3513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390240" y="5962442"/>
            <a:ext cx="14863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) sonicate (15 min, 22-25 °C)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) shake (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800 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r>
              <a:rPr lang="de-DE" sz="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,100 min, 22 °C)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3) centrifuge (4696 g, 10 min, 22 °C) </a:t>
            </a:r>
          </a:p>
        </p:txBody>
      </p:sp>
      <p:cxnSp>
        <p:nvCxnSpPr>
          <p:cNvPr id="90" name="Straight Arrow Connector 89"/>
          <p:cNvCxnSpPr/>
          <p:nvPr/>
        </p:nvCxnSpPr>
        <p:spPr>
          <a:xfrm>
            <a:off x="1790700" y="6006892"/>
            <a:ext cx="0" cy="3513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90"/>
          <p:cNvSpPr txBox="1"/>
          <p:nvPr/>
        </p:nvSpPr>
        <p:spPr>
          <a:xfrm>
            <a:off x="1967862" y="3822671"/>
            <a:ext cx="89800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ollect supernatant 1</a:t>
            </a:r>
          </a:p>
        </p:txBody>
      </p:sp>
      <p:pic>
        <p:nvPicPr>
          <p:cNvPr id="92" name="Picture 9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9881" y="3636194"/>
            <a:ext cx="307048" cy="747810"/>
          </a:xfrm>
          <a:prstGeom prst="rect">
            <a:avLst/>
          </a:prstGeom>
        </p:spPr>
      </p:pic>
      <p:cxnSp>
        <p:nvCxnSpPr>
          <p:cNvPr id="93" name="Straight Arrow Connector 92"/>
          <p:cNvCxnSpPr/>
          <p:nvPr/>
        </p:nvCxnSpPr>
        <p:spPr>
          <a:xfrm rot="-5400000">
            <a:off x="2403880" y="3485300"/>
            <a:ext cx="0" cy="109728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Arrow Connector 93"/>
          <p:cNvCxnSpPr/>
          <p:nvPr/>
        </p:nvCxnSpPr>
        <p:spPr>
          <a:xfrm rot="-10800000">
            <a:off x="3125210" y="4506380"/>
            <a:ext cx="0" cy="27432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5" name="Picture 9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4824" y="4757056"/>
            <a:ext cx="158667" cy="388000"/>
          </a:xfrm>
          <a:prstGeom prst="rect">
            <a:avLst/>
          </a:prstGeom>
        </p:spPr>
      </p:pic>
      <p:sp>
        <p:nvSpPr>
          <p:cNvPr id="96" name="TextBox 95"/>
          <p:cNvSpPr txBox="1"/>
          <p:nvPr/>
        </p:nvSpPr>
        <p:spPr>
          <a:xfrm>
            <a:off x="4752975" y="4480250"/>
            <a:ext cx="851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transfer 1500 µL in </a:t>
            </a:r>
          </a:p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-ml PP tube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4752975" y="5165741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evaporate to dryness 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(40 °C, 4 mbar)</a:t>
            </a:r>
          </a:p>
        </p:txBody>
      </p:sp>
      <p:pic>
        <p:nvPicPr>
          <p:cNvPr id="98" name="Picture 9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3218" y="5510928"/>
            <a:ext cx="158000" cy="388000"/>
          </a:xfrm>
          <a:prstGeom prst="rect">
            <a:avLst/>
          </a:prstGeom>
        </p:spPr>
      </p:pic>
      <p:sp>
        <p:nvSpPr>
          <p:cNvPr id="99" name="TextBox 98"/>
          <p:cNvSpPr txBox="1"/>
          <p:nvPr/>
        </p:nvSpPr>
        <p:spPr>
          <a:xfrm>
            <a:off x="4654740" y="5869540"/>
            <a:ext cx="1407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) add 200 µL 80% aq. MeOH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) shake (1800 min</a:t>
            </a:r>
            <a:r>
              <a:rPr lang="de-DE" sz="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,10 min, 22 °C)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3) sonicate (10 min, 22 °C)</a:t>
            </a:r>
          </a:p>
        </p:txBody>
      </p:sp>
      <p:pic>
        <p:nvPicPr>
          <p:cNvPr id="100" name="Picture 9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3026" y="6253157"/>
            <a:ext cx="158667" cy="388000"/>
          </a:xfrm>
          <a:prstGeom prst="rect">
            <a:avLst/>
          </a:prstGeom>
        </p:spPr>
      </p:pic>
      <p:sp>
        <p:nvSpPr>
          <p:cNvPr id="102" name="TextBox 101"/>
          <p:cNvSpPr txBox="1"/>
          <p:nvPr/>
        </p:nvSpPr>
        <p:spPr>
          <a:xfrm>
            <a:off x="4653185" y="6637588"/>
            <a:ext cx="1433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) store for at least 18 h at 6 °C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) centrifuge (13000 g, 10 min, 6 °C)</a:t>
            </a:r>
          </a:p>
        </p:txBody>
      </p:sp>
      <p:pic>
        <p:nvPicPr>
          <p:cNvPr id="103" name="Picture 10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3656" y="6995554"/>
            <a:ext cx="158667" cy="388000"/>
          </a:xfrm>
          <a:prstGeom prst="rect">
            <a:avLst/>
          </a:prstGeom>
        </p:spPr>
      </p:pic>
      <p:cxnSp>
        <p:nvCxnSpPr>
          <p:cNvPr id="105" name="Straight Connector 104"/>
          <p:cNvCxnSpPr/>
          <p:nvPr/>
        </p:nvCxnSpPr>
        <p:spPr>
          <a:xfrm>
            <a:off x="1790700" y="7083930"/>
            <a:ext cx="0" cy="16462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Connector 107"/>
          <p:cNvCxnSpPr/>
          <p:nvPr/>
        </p:nvCxnSpPr>
        <p:spPr>
          <a:xfrm rot="-5400000">
            <a:off x="2456089" y="6581046"/>
            <a:ext cx="0" cy="13350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Arrow Connector 108"/>
          <p:cNvCxnSpPr/>
          <p:nvPr/>
        </p:nvCxnSpPr>
        <p:spPr>
          <a:xfrm rot="-5400000">
            <a:off x="3828654" y="3485300"/>
            <a:ext cx="0" cy="109728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/>
          <p:cNvSpPr txBox="1"/>
          <p:nvPr/>
        </p:nvSpPr>
        <p:spPr>
          <a:xfrm>
            <a:off x="3255046" y="3732465"/>
            <a:ext cx="10935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) adjust volume to 25 mL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) mix by inversion</a:t>
            </a:r>
          </a:p>
        </p:txBody>
      </p:sp>
      <p:cxnSp>
        <p:nvCxnSpPr>
          <p:cNvPr id="111" name="Straight Arrow Connector 110"/>
          <p:cNvCxnSpPr/>
          <p:nvPr/>
        </p:nvCxnSpPr>
        <p:spPr>
          <a:xfrm>
            <a:off x="4571996" y="4425413"/>
            <a:ext cx="0" cy="3513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Arrow Connector 111"/>
          <p:cNvCxnSpPr/>
          <p:nvPr/>
        </p:nvCxnSpPr>
        <p:spPr>
          <a:xfrm>
            <a:off x="4571996" y="5153355"/>
            <a:ext cx="0" cy="3513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Arrow Connector 112"/>
          <p:cNvCxnSpPr/>
          <p:nvPr/>
        </p:nvCxnSpPr>
        <p:spPr>
          <a:xfrm>
            <a:off x="4572794" y="5918042"/>
            <a:ext cx="0" cy="3513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Arrow Connector 113"/>
          <p:cNvCxnSpPr/>
          <p:nvPr/>
        </p:nvCxnSpPr>
        <p:spPr>
          <a:xfrm>
            <a:off x="4571996" y="6654921"/>
            <a:ext cx="0" cy="3513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Arrow Connector 114"/>
          <p:cNvCxnSpPr/>
          <p:nvPr/>
        </p:nvCxnSpPr>
        <p:spPr>
          <a:xfrm>
            <a:off x="4571992" y="7394696"/>
            <a:ext cx="0" cy="3513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TextBox 115"/>
          <p:cNvSpPr txBox="1"/>
          <p:nvPr/>
        </p:nvSpPr>
        <p:spPr>
          <a:xfrm>
            <a:off x="4655562" y="7392451"/>
            <a:ext cx="14766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) transfer supernatant into HPLC vial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) store at 6 °C until analysis</a:t>
            </a:r>
          </a:p>
        </p:txBody>
      </p:sp>
      <p:sp>
        <p:nvSpPr>
          <p:cNvPr id="117" name="TextBox 116"/>
          <p:cNvSpPr txBox="1"/>
          <p:nvPr/>
        </p:nvSpPr>
        <p:spPr>
          <a:xfrm>
            <a:off x="4041539" y="7794297"/>
            <a:ext cx="1057511" cy="184666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UHPLC/ESI(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)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-QTOFMS</a:t>
            </a:r>
          </a:p>
        </p:txBody>
      </p:sp>
      <p:sp>
        <p:nvSpPr>
          <p:cNvPr id="118" name="TextBox 117"/>
          <p:cNvSpPr txBox="1"/>
          <p:nvPr/>
        </p:nvSpPr>
        <p:spPr>
          <a:xfrm>
            <a:off x="1959246" y="1766126"/>
            <a:ext cx="20874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IS Mix = 50 µM 4-aminohippuric acid, 5 µM kinetine, 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5 µM aspartame, 10 µM biochanin A in 50 % aq. EtOH</a:t>
            </a:r>
          </a:p>
        </p:txBody>
      </p:sp>
      <p:sp>
        <p:nvSpPr>
          <p:cNvPr id="119" name="TextBox 118"/>
          <p:cNvSpPr txBox="1"/>
          <p:nvPr/>
        </p:nvSpPr>
        <p:spPr>
          <a:xfrm>
            <a:off x="1964429" y="2769723"/>
            <a:ext cx="16930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!! Control temperature during sonication !! 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If necessary add ice 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to to the ultrasonic bath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lower 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temperature.</a:t>
            </a:r>
            <a:endParaRPr lang="de-DE" sz="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1967862" y="5977439"/>
            <a:ext cx="955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!! Control temperature 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during sonication !! </a:t>
            </a:r>
          </a:p>
          <a:p>
            <a:endParaRPr lang="de-DE" sz="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1965008" y="741490"/>
            <a:ext cx="79220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curacy 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 10 mg</a:t>
            </a:r>
            <a:endParaRPr lang="de-DE" sz="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3375455" y="6658705"/>
            <a:ext cx="13035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!!Precipitation of residual starch </a:t>
            </a:r>
          </a:p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nd proteins!!</a:t>
            </a:r>
          </a:p>
          <a:p>
            <a:endParaRPr lang="de-DE" sz="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42729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318998" y="34238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518863" y="346163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19268" y="243849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510606" y="2437975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15186" y="453461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56684" y="7919610"/>
            <a:ext cx="622554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5.</a:t>
            </a:r>
            <a:r>
              <a:rPr lang="de-DE" sz="10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otal ion chromatagrams (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80-1700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obtained from a hydroethanolic whole wheat grain extract (´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JB Asano´) by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UHPLC/ESI-QTOFMS in positive ion mode using a Zorbax RRHD Eclipse Plus C18 column (100 x 2.1 mm, 1.8 µm particle size) in combination with different eluent systems and gradient programs. All chromatograms were obtained at a flow rate of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400 µL min</a:t>
            </a:r>
            <a:r>
              <a:rPr lang="de-DE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1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nd a column temperature of 40 °C.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539470" y="4533017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550100" y="412481"/>
            <a:ext cx="2990025" cy="1781517"/>
            <a:chOff x="553275" y="82292"/>
            <a:chExt cx="2990025" cy="1781517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53275" y="82292"/>
              <a:ext cx="2990025" cy="1781517"/>
            </a:xfrm>
            <a:prstGeom prst="rect">
              <a:avLst/>
            </a:prstGeom>
          </p:spPr>
        </p:pic>
        <p:sp>
          <p:nvSpPr>
            <p:cNvPr id="28" name="Rectangle 27"/>
            <p:cNvSpPr/>
            <p:nvPr/>
          </p:nvSpPr>
          <p:spPr>
            <a:xfrm>
              <a:off x="834231" y="183356"/>
              <a:ext cx="91440" cy="1493837"/>
            </a:xfrm>
            <a:prstGeom prst="rect">
              <a:avLst/>
            </a:prstGeom>
            <a:solidFill>
              <a:schemeClr val="accent1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0" name="Rectangle 29"/>
            <p:cNvSpPr/>
            <p:nvPr/>
          </p:nvSpPr>
          <p:spPr>
            <a:xfrm>
              <a:off x="925377" y="183356"/>
              <a:ext cx="788526" cy="1490472"/>
            </a:xfrm>
            <a:prstGeom prst="rect">
              <a:avLst/>
            </a:prstGeom>
            <a:solidFill>
              <a:schemeClr val="accent4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1" name="Rectangle 30"/>
            <p:cNvSpPr/>
            <p:nvPr/>
          </p:nvSpPr>
          <p:spPr>
            <a:xfrm>
              <a:off x="2138362" y="182562"/>
              <a:ext cx="1262063" cy="1490472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9" name="Rectangle 28"/>
            <p:cNvSpPr/>
            <p:nvPr/>
          </p:nvSpPr>
          <p:spPr>
            <a:xfrm>
              <a:off x="1713419" y="182561"/>
              <a:ext cx="424943" cy="1493837"/>
            </a:xfrm>
            <a:prstGeom prst="rect">
              <a:avLst/>
            </a:prstGeom>
            <a:solidFill>
              <a:srgbClr val="C00000">
                <a:alpha val="5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547081" y="2507540"/>
            <a:ext cx="2989033" cy="1781517"/>
            <a:chOff x="462055" y="2042138"/>
            <a:chExt cx="2989033" cy="1781517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62055" y="2042138"/>
              <a:ext cx="2989033" cy="1781517"/>
            </a:xfrm>
            <a:prstGeom prst="rect">
              <a:avLst/>
            </a:prstGeom>
          </p:spPr>
        </p:pic>
        <p:sp>
          <p:nvSpPr>
            <p:cNvPr id="33" name="Rectangle 32"/>
            <p:cNvSpPr/>
            <p:nvPr/>
          </p:nvSpPr>
          <p:spPr>
            <a:xfrm>
              <a:off x="754852" y="2142418"/>
              <a:ext cx="91440" cy="1493837"/>
            </a:xfrm>
            <a:prstGeom prst="rect">
              <a:avLst/>
            </a:prstGeom>
            <a:solidFill>
              <a:schemeClr val="accent1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5" name="Rectangle 34"/>
            <p:cNvSpPr/>
            <p:nvPr/>
          </p:nvSpPr>
          <p:spPr>
            <a:xfrm>
              <a:off x="843915" y="2143222"/>
              <a:ext cx="935466" cy="1490472"/>
            </a:xfrm>
            <a:prstGeom prst="rect">
              <a:avLst/>
            </a:prstGeom>
            <a:solidFill>
              <a:schemeClr val="accent4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6" name="Rectangle 35"/>
            <p:cNvSpPr/>
            <p:nvPr/>
          </p:nvSpPr>
          <p:spPr>
            <a:xfrm>
              <a:off x="1776586" y="2143154"/>
              <a:ext cx="470933" cy="1493837"/>
            </a:xfrm>
            <a:prstGeom prst="rect">
              <a:avLst/>
            </a:prstGeom>
            <a:solidFill>
              <a:srgbClr val="C00000">
                <a:alpha val="5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7" name="Rectangle 36"/>
            <p:cNvSpPr/>
            <p:nvPr/>
          </p:nvSpPr>
          <p:spPr>
            <a:xfrm>
              <a:off x="2247899" y="2143222"/>
              <a:ext cx="1060451" cy="1490472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553886" y="4598301"/>
            <a:ext cx="2990025" cy="1781517"/>
            <a:chOff x="553274" y="3989284"/>
            <a:chExt cx="2990025" cy="1781517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53274" y="3989284"/>
              <a:ext cx="2990025" cy="1781517"/>
            </a:xfrm>
            <a:prstGeom prst="rect">
              <a:avLst/>
            </a:prstGeom>
          </p:spPr>
        </p:pic>
        <p:sp>
          <p:nvSpPr>
            <p:cNvPr id="38" name="Rectangle 37"/>
            <p:cNvSpPr/>
            <p:nvPr/>
          </p:nvSpPr>
          <p:spPr>
            <a:xfrm>
              <a:off x="825505" y="4088909"/>
              <a:ext cx="100166" cy="1493837"/>
            </a:xfrm>
            <a:prstGeom prst="rect">
              <a:avLst/>
            </a:prstGeom>
            <a:solidFill>
              <a:schemeClr val="accent1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9" name="Rectangle 38"/>
            <p:cNvSpPr/>
            <p:nvPr/>
          </p:nvSpPr>
          <p:spPr>
            <a:xfrm>
              <a:off x="924968" y="4090490"/>
              <a:ext cx="1172210" cy="1490472"/>
            </a:xfrm>
            <a:prstGeom prst="rect">
              <a:avLst/>
            </a:prstGeom>
            <a:solidFill>
              <a:schemeClr val="accent4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0" name="Rectangle 39"/>
            <p:cNvSpPr/>
            <p:nvPr/>
          </p:nvSpPr>
          <p:spPr>
            <a:xfrm>
              <a:off x="2092588" y="4089696"/>
              <a:ext cx="531549" cy="1493837"/>
            </a:xfrm>
            <a:prstGeom prst="rect">
              <a:avLst/>
            </a:prstGeom>
            <a:solidFill>
              <a:srgbClr val="C00000">
                <a:alpha val="5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1" name="Rectangle 40"/>
            <p:cNvSpPr/>
            <p:nvPr/>
          </p:nvSpPr>
          <p:spPr>
            <a:xfrm>
              <a:off x="2622068" y="4091379"/>
              <a:ext cx="777745" cy="1490472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3751268" y="4597738"/>
            <a:ext cx="2990025" cy="1780527"/>
            <a:chOff x="3646995" y="3959691"/>
            <a:chExt cx="2990025" cy="1780527"/>
          </a:xfrm>
        </p:grpSpPr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646995" y="3959691"/>
              <a:ext cx="2990025" cy="1780527"/>
            </a:xfrm>
            <a:prstGeom prst="rect">
              <a:avLst/>
            </a:prstGeom>
          </p:spPr>
        </p:pic>
        <p:sp>
          <p:nvSpPr>
            <p:cNvPr id="46" name="Rectangle 45"/>
            <p:cNvSpPr/>
            <p:nvPr/>
          </p:nvSpPr>
          <p:spPr>
            <a:xfrm>
              <a:off x="3928067" y="4061033"/>
              <a:ext cx="121708" cy="1493837"/>
            </a:xfrm>
            <a:prstGeom prst="rect">
              <a:avLst/>
            </a:prstGeom>
            <a:solidFill>
              <a:schemeClr val="accent1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7" name="Rectangle 46"/>
            <p:cNvSpPr/>
            <p:nvPr/>
          </p:nvSpPr>
          <p:spPr>
            <a:xfrm>
              <a:off x="4047810" y="4059723"/>
              <a:ext cx="2193447" cy="1490472"/>
            </a:xfrm>
            <a:prstGeom prst="rect">
              <a:avLst/>
            </a:prstGeom>
            <a:solidFill>
              <a:schemeClr val="accent4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8" name="Rectangle 47"/>
            <p:cNvSpPr/>
            <p:nvPr/>
          </p:nvSpPr>
          <p:spPr>
            <a:xfrm>
              <a:off x="6241258" y="4059723"/>
              <a:ext cx="254792" cy="1493837"/>
            </a:xfrm>
            <a:prstGeom prst="rect">
              <a:avLst/>
            </a:prstGeom>
            <a:solidFill>
              <a:srgbClr val="C00000">
                <a:alpha val="5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3751535" y="2510495"/>
            <a:ext cx="2989033" cy="1780527"/>
            <a:chOff x="3646995" y="2049822"/>
            <a:chExt cx="2989033" cy="1780527"/>
          </a:xfrm>
        </p:grpSpPr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646995" y="2049822"/>
              <a:ext cx="2989033" cy="1780527"/>
            </a:xfrm>
            <a:prstGeom prst="rect">
              <a:avLst/>
            </a:prstGeom>
          </p:spPr>
        </p:pic>
        <p:sp>
          <p:nvSpPr>
            <p:cNvPr id="45" name="Rectangle 44"/>
            <p:cNvSpPr/>
            <p:nvPr/>
          </p:nvSpPr>
          <p:spPr>
            <a:xfrm>
              <a:off x="3926920" y="2149108"/>
              <a:ext cx="121708" cy="1493837"/>
            </a:xfrm>
            <a:prstGeom prst="rect">
              <a:avLst/>
            </a:prstGeom>
            <a:solidFill>
              <a:schemeClr val="accent1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9" name="Rectangle 48"/>
            <p:cNvSpPr/>
            <p:nvPr/>
          </p:nvSpPr>
          <p:spPr>
            <a:xfrm>
              <a:off x="4047810" y="2150092"/>
              <a:ext cx="1814828" cy="1490472"/>
            </a:xfrm>
            <a:prstGeom prst="rect">
              <a:avLst/>
            </a:prstGeom>
            <a:solidFill>
              <a:schemeClr val="accent4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0" name="Rectangle 49"/>
            <p:cNvSpPr/>
            <p:nvPr/>
          </p:nvSpPr>
          <p:spPr>
            <a:xfrm>
              <a:off x="5859068" y="2150273"/>
              <a:ext cx="460769" cy="1493837"/>
            </a:xfrm>
            <a:prstGeom prst="rect">
              <a:avLst/>
            </a:prstGeom>
            <a:solidFill>
              <a:srgbClr val="C00000">
                <a:alpha val="5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1" name="Rectangle 50"/>
            <p:cNvSpPr/>
            <p:nvPr/>
          </p:nvSpPr>
          <p:spPr>
            <a:xfrm>
              <a:off x="6319838" y="2150092"/>
              <a:ext cx="176212" cy="1490472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3749025" y="412150"/>
            <a:ext cx="2990025" cy="1780527"/>
            <a:chOff x="3634257" y="83282"/>
            <a:chExt cx="2990025" cy="1780527"/>
          </a:xfrm>
        </p:grpSpPr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634257" y="83282"/>
              <a:ext cx="2990025" cy="1780527"/>
            </a:xfrm>
            <a:prstGeom prst="rect">
              <a:avLst/>
            </a:prstGeom>
          </p:spPr>
        </p:pic>
        <p:sp>
          <p:nvSpPr>
            <p:cNvPr id="42" name="Rectangle 41"/>
            <p:cNvSpPr/>
            <p:nvPr/>
          </p:nvSpPr>
          <p:spPr>
            <a:xfrm>
              <a:off x="3921986" y="182372"/>
              <a:ext cx="121708" cy="1493837"/>
            </a:xfrm>
            <a:prstGeom prst="rect">
              <a:avLst/>
            </a:prstGeom>
            <a:solidFill>
              <a:schemeClr val="accent1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2" name="Rectangle 51"/>
            <p:cNvSpPr/>
            <p:nvPr/>
          </p:nvSpPr>
          <p:spPr>
            <a:xfrm>
              <a:off x="4043694" y="183356"/>
              <a:ext cx="1402225" cy="1490472"/>
            </a:xfrm>
            <a:prstGeom prst="rect">
              <a:avLst/>
            </a:prstGeom>
            <a:solidFill>
              <a:schemeClr val="accent4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3" name="Rectangle 52"/>
            <p:cNvSpPr/>
            <p:nvPr/>
          </p:nvSpPr>
          <p:spPr>
            <a:xfrm>
              <a:off x="5445919" y="182372"/>
              <a:ext cx="509587" cy="1493837"/>
            </a:xfrm>
            <a:prstGeom prst="rect">
              <a:avLst/>
            </a:prstGeom>
            <a:solidFill>
              <a:srgbClr val="C00000">
                <a:alpha val="5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4" name="Rectangle 53"/>
            <p:cNvSpPr/>
            <p:nvPr/>
          </p:nvSpPr>
          <p:spPr>
            <a:xfrm>
              <a:off x="5956521" y="183480"/>
              <a:ext cx="530352" cy="1490472"/>
            </a:xfrm>
            <a:prstGeom prst="rect">
              <a:avLst/>
            </a:prstGeom>
            <a:solidFill>
              <a:schemeClr val="accent6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2652839" y="6622665"/>
            <a:ext cx="2009776" cy="961496"/>
            <a:chOff x="762000" y="6349175"/>
            <a:chExt cx="2009776" cy="961496"/>
          </a:xfrm>
        </p:grpSpPr>
        <p:sp>
          <p:nvSpPr>
            <p:cNvPr id="56" name="Rectangle 55"/>
            <p:cNvSpPr/>
            <p:nvPr/>
          </p:nvSpPr>
          <p:spPr>
            <a:xfrm>
              <a:off x="762000" y="6349175"/>
              <a:ext cx="2009776" cy="240374"/>
            </a:xfrm>
            <a:prstGeom prst="rect">
              <a:avLst/>
            </a:prstGeom>
            <a:solidFill>
              <a:schemeClr val="accent1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0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lar fraction</a:t>
              </a:r>
              <a:endParaRPr lang="de-DE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Rectangle 56"/>
            <p:cNvSpPr/>
            <p:nvPr/>
          </p:nvSpPr>
          <p:spPr>
            <a:xfrm>
              <a:off x="763578" y="6589549"/>
              <a:ext cx="2008198" cy="240374"/>
            </a:xfrm>
            <a:prstGeom prst="rect">
              <a:avLst/>
            </a:prstGeom>
            <a:solidFill>
              <a:srgbClr val="FFC000">
                <a:alpha val="5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0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mi-polar </a:t>
              </a:r>
              <a:r>
                <a:rPr lang="de-DE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raction</a:t>
              </a:r>
            </a:p>
          </p:txBody>
        </p:sp>
        <p:sp>
          <p:nvSpPr>
            <p:cNvPr id="58" name="Rectangle 57"/>
            <p:cNvSpPr/>
            <p:nvPr/>
          </p:nvSpPr>
          <p:spPr>
            <a:xfrm>
              <a:off x="763578" y="6829923"/>
              <a:ext cx="2008198" cy="240374"/>
            </a:xfrm>
            <a:prstGeom prst="rect">
              <a:avLst/>
            </a:prstGeom>
            <a:solidFill>
              <a:srgbClr val="C00000">
                <a:alpha val="5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0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luten protein fraction</a:t>
              </a:r>
              <a:endParaRPr lang="de-DE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Rectangle 58"/>
            <p:cNvSpPr/>
            <p:nvPr/>
          </p:nvSpPr>
          <p:spPr>
            <a:xfrm>
              <a:off x="766753" y="7070297"/>
              <a:ext cx="2005023" cy="240374"/>
            </a:xfrm>
            <a:prstGeom prst="rect">
              <a:avLst/>
            </a:prstGeom>
            <a:solidFill>
              <a:srgbClr val="92D050">
                <a:alpha val="5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0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polar fraction (polar lipids)</a:t>
              </a:r>
              <a:endParaRPr lang="de-DE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4818066" y="6339349"/>
            <a:ext cx="95090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etention time [min]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616461" y="6340417"/>
            <a:ext cx="95090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etention time [min]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 rot="16200000">
            <a:off x="125296" y="1153388"/>
            <a:ext cx="6639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el. intensity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768607" y="163561"/>
            <a:ext cx="26244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 = 0.1% HCO</a:t>
            </a:r>
            <a:r>
              <a:rPr lang="de-DE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 in H</a:t>
            </a:r>
            <a:r>
              <a:rPr lang="de-DE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O, B = 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0.1% HCO</a:t>
            </a:r>
            <a:r>
              <a:rPr lang="de-DE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H in 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H</a:t>
            </a:r>
            <a:r>
              <a:rPr lang="de-DE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N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0-15 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in, 5 → 95% B; 15-16 min, 95% B 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3959491" y="168319"/>
            <a:ext cx="26308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 = 0.1% HCO</a:t>
            </a:r>
            <a:r>
              <a:rPr lang="de-DE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 in H</a:t>
            </a:r>
            <a:r>
              <a:rPr lang="de-DE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O, B = 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0.1% HCO</a:t>
            </a:r>
            <a:r>
              <a:rPr lang="de-DE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H in 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H</a:t>
            </a:r>
            <a:r>
              <a:rPr lang="de-DE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OH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0-15 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in, 5 → 95% B; 15-16 min, 95% B 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754313" y="2254321"/>
            <a:ext cx="26244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 = 0.1% HCO</a:t>
            </a:r>
            <a:r>
              <a:rPr lang="de-DE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 in H</a:t>
            </a:r>
            <a:r>
              <a:rPr lang="de-DE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O, B = 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0.1% HCO</a:t>
            </a:r>
            <a:r>
              <a:rPr lang="de-DE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H in 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H</a:t>
            </a:r>
            <a:r>
              <a:rPr lang="de-DE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N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0-15 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in, 5 → 80% B; 15-16 min, 80 → 95% 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66" name="TextBox 65"/>
          <p:cNvSpPr txBox="1"/>
          <p:nvPr/>
        </p:nvSpPr>
        <p:spPr>
          <a:xfrm rot="16200000">
            <a:off x="126639" y="3241066"/>
            <a:ext cx="6639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el. intensity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3973775" y="2254315"/>
            <a:ext cx="26308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 = 0.1% HCO</a:t>
            </a:r>
            <a:r>
              <a:rPr lang="de-DE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 in H</a:t>
            </a:r>
            <a:r>
              <a:rPr lang="de-DE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O, B = 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0.1% HCO</a:t>
            </a:r>
            <a:r>
              <a:rPr lang="de-DE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H in 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H</a:t>
            </a:r>
            <a:r>
              <a:rPr lang="de-DE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OH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0-15 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in, 5 → 80% B; 15-16 min, 80 → 95% 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68" name="TextBox 67"/>
          <p:cNvSpPr txBox="1"/>
          <p:nvPr/>
        </p:nvSpPr>
        <p:spPr>
          <a:xfrm rot="16200000">
            <a:off x="129041" y="5339937"/>
            <a:ext cx="6639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el. intensity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778128" y="4345755"/>
            <a:ext cx="26244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 = 0.1% HCO</a:t>
            </a:r>
            <a:r>
              <a:rPr lang="de-DE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 in H</a:t>
            </a:r>
            <a:r>
              <a:rPr lang="de-DE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O, B = 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0.1% HCO</a:t>
            </a:r>
            <a:r>
              <a:rPr lang="de-DE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H in 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H</a:t>
            </a:r>
            <a:r>
              <a:rPr lang="de-DE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N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0-15 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in, 5 → 65% B; 15-16 min, 65 → 95% 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3978543" y="4386973"/>
            <a:ext cx="26308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 = 0.1% HCO</a:t>
            </a:r>
            <a:r>
              <a:rPr lang="de-DE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 in H</a:t>
            </a:r>
            <a:r>
              <a:rPr lang="de-DE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O, B = 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0.1% HCO</a:t>
            </a:r>
            <a:r>
              <a:rPr lang="de-DE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H in 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H</a:t>
            </a:r>
            <a:r>
              <a:rPr lang="de-DE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OH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0-15 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in, 5 → 65% B; 15-16 min, 65 → 95% 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7693968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657" y="4114800"/>
            <a:ext cx="3066303" cy="2311611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30309" y="4114800"/>
            <a:ext cx="3066303" cy="231161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04953" y="3776841"/>
            <a:ext cx="15648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affeic acid </a:t>
            </a:r>
          </a:p>
          <a:p>
            <a:pPr algn="ctr"/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P11, EIC </a:t>
            </a:r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179.035 [M-H]</a:t>
            </a:r>
            <a:r>
              <a:rPr lang="de-DE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982324" y="4205279"/>
            <a:ext cx="971741" cy="184666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0 mM AmFor (pH 6.2)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777340" y="4584873"/>
            <a:ext cx="1382110" cy="184666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0.1 % HFor/10 mM AmFor (pH 3.4)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034690" y="4962086"/>
            <a:ext cx="873957" cy="184666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0.1 % HFor (pH 2.9)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994229" y="5325738"/>
            <a:ext cx="946093" cy="184666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0 mM AmAc (pH 6.8)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805168" y="5700570"/>
            <a:ext cx="1330814" cy="184666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0.1 % HAc/10 mM AmAc (pH 4.5)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032734" y="6068252"/>
            <a:ext cx="869149" cy="184666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0.1 % HAc (pH 3.4)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301115" y="3776841"/>
            <a:ext cx="1576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zelaic acid </a:t>
            </a:r>
          </a:p>
          <a:p>
            <a:pPr algn="ctr"/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AS3, EIC </a:t>
            </a:r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187.098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[M-H]</a:t>
            </a:r>
            <a:r>
              <a:rPr lang="de-DE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7482" y="1302122"/>
            <a:ext cx="3066303" cy="2311611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872068" y="957957"/>
            <a:ext cx="18485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de-DE" sz="8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Coumaroyl-</a:t>
            </a:r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de-DE" sz="8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feruloyl-spermine</a:t>
            </a:r>
          </a:p>
          <a:p>
            <a:pPr algn="ctr"/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HCAA20, EIC </a:t>
            </a:r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525.307 [M+H]</a:t>
            </a:r>
            <a:r>
              <a:rPr lang="de-DE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29383" y="1300168"/>
            <a:ext cx="3066303" cy="2311611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4189635" y="958606"/>
            <a:ext cx="18245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de-DE" sz="8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Sinapoyl-agmatine</a:t>
            </a:r>
          </a:p>
          <a:p>
            <a:pPr algn="ctr"/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HCAA11, EIC </a:t>
            </a:r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337.187 [M+H]</a:t>
            </a:r>
            <a:r>
              <a:rPr lang="de-DE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981602" y="1399508"/>
            <a:ext cx="971741" cy="184666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0 mM AmFor (pH 6.2)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776414" y="1770146"/>
            <a:ext cx="1382110" cy="184666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0.1 % HFor/10 mM AmFor (pH 3.4)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031293" y="2154452"/>
            <a:ext cx="873957" cy="184666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0.1 % HFor (pH 2.9)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996654" y="2529770"/>
            <a:ext cx="946093" cy="184666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0 mM AmAc (pH 6.8)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803166" y="2899947"/>
            <a:ext cx="1330814" cy="184666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0.1 % HAc/10 mM AmAc (pH 4.5)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034401" y="3269007"/>
            <a:ext cx="869149" cy="184666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0.1 % HAc (pH 3.4)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17494" y="6668285"/>
            <a:ext cx="622554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6.</a:t>
            </a:r>
            <a:r>
              <a:rPr lang="de-DE" sz="10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tention behavior of acylated biogenic amines and weak acids dependent on eluent additive. Extracted ion chromatograms were obtained from a hydroethanolic wheat grain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tract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´JB Asano´) by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UHPLC/ESI-QTOFMS using a Zorbax RRHD Eclipse Plus C18 column (2.1 mm x 100 mm, 1.8 µm particle size) and water/additive  and methanol/additive as eluents.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e following gradient program was used: 0-15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in linear from 5 % to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% B, 15-16 min, linear from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to 95 %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ll chromatograms were obtained at a flow rate of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400 µL min</a:t>
            </a:r>
            <a:r>
              <a:rPr lang="de-DE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1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nd a column temperature of 40 °C. pH values shown above were obtained from water/additive mixtures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t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22 °C. HFor, fromic acid; AmFor,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mmonium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iat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HAc, acetic acid; AmAc, ammonium acetate. 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0032" y="389446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359977" y="3900809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358365" y="1075621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0758" y="107562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1247537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1262" y="2636772"/>
            <a:ext cx="2529182" cy="15066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8188" y="1030584"/>
            <a:ext cx="2528344" cy="1507437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662689" y="743960"/>
            <a:ext cx="27367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pigenin </a:t>
            </a:r>
            <a:r>
              <a:rPr lang="de-DE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Pent-</a:t>
            </a:r>
            <a:r>
              <a:rPr lang="de-DE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Hex isomer #3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(F2-3) </a:t>
            </a:r>
          </a:p>
          <a:p>
            <a:pPr algn="ctr"/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565.155 [M+H]</a:t>
            </a:r>
            <a:r>
              <a:rPr lang="de-DE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, t</a:t>
            </a:r>
            <a:r>
              <a:rPr lang="de-DE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8.05 min)  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146246" y="1083854"/>
            <a:ext cx="10903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inter-batch 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= 20.7%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intra-batch/extraction 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= 0%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intra-batch/instrument 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= 2.6%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207490" y="2685976"/>
            <a:ext cx="10903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inter-batch 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= 1.0%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intra-batch/extraction 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= 0.5%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intra-batch/instrument 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= 1.2%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6200000">
            <a:off x="69643" y="1640018"/>
            <a:ext cx="698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w data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-214894" y="3171690"/>
            <a:ext cx="12717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gnal drift-corrected </a:t>
            </a:r>
          </a:p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d normalized data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155889" y="1648321"/>
            <a:ext cx="114133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eak area/dry weight [mg</a:t>
            </a:r>
            <a:r>
              <a:rPr lang="de-DE" sz="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/>
          <a:srcRect l="85643" t="26200" b="27463"/>
          <a:stretch/>
        </p:blipFill>
        <p:spPr>
          <a:xfrm>
            <a:off x="5931653" y="2175512"/>
            <a:ext cx="428993" cy="8255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94721" y="2635190"/>
            <a:ext cx="2528344" cy="1507437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85727" y="1034414"/>
            <a:ext cx="2527505" cy="1507437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4769518" y="1092429"/>
            <a:ext cx="1104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inter-batch 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= 26.8%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intra-batch/extraction 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= 0%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intra-batch/instrument 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= 13.2%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748231" y="749850"/>
            <a:ext cx="19477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,4-Dihydroxy-BOA 2-</a:t>
            </a:r>
            <a:r>
              <a:rPr lang="de-DE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Hex</a:t>
            </a:r>
            <a:r>
              <a:rPr lang="de-DE" sz="8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(BX4) </a:t>
            </a:r>
          </a:p>
          <a:p>
            <a:pPr algn="ctr"/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504.136 [M-H]</a:t>
            </a:r>
            <a:r>
              <a:rPr lang="de-DE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, t</a:t>
            </a:r>
            <a:r>
              <a:rPr lang="de-DE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4.77 min)  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154302" y="3221536"/>
            <a:ext cx="114133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normalized peak area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831066" y="2687290"/>
            <a:ext cx="10647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inter-batch 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= 2.8%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intra-batch/extraction 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= 0.9%</a:t>
            </a:r>
          </a:p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intra-batch/intrument 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= 2.7%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38802" y="89285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209032" y="885761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209026" y="2485972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46777" y="248596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519948" y="4085956"/>
            <a:ext cx="114133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njection order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146467" y="4085478"/>
            <a:ext cx="114133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njection order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49500" y="4410230"/>
            <a:ext cx="622554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7.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bundance profiles of two metabolites analyzed within the repeatability experiment. Dry weight normalized peak areas of quantifier ions are shown in 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Signal-drift corrected and normalized peak areas based on QC samples are shown in 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CV,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efficient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ariatio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8922624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86" y="309987"/>
            <a:ext cx="3419153" cy="2055596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971" y="2289389"/>
            <a:ext cx="3419153" cy="205559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686" y="4311646"/>
            <a:ext cx="3419153" cy="205559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33887" y="314750"/>
            <a:ext cx="3416867" cy="2055596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26844" y="2292617"/>
            <a:ext cx="3416867" cy="2054455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43194" y="4306881"/>
            <a:ext cx="3416867" cy="2054455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25097" y="6438900"/>
            <a:ext cx="620349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rgeted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analysis of metabolite profiles. Metabolite profiles were obtained from 64 hydroethanolic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hole wheat grain extracts (8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cultivars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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4 agronomic replicates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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2 technical replicates) using UHPLC/ESI-QTOFMS in both ion modes. A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ooled QC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ample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as repeatedly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injected 19 times within the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atch. Principal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component analysis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as performed using drift-corrected and normalized abundances of 167 metabolites (isomers combined). Pairwise score plots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of the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irst three prinicipal components are shown in 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Corresponding loading plots are shown in 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9852" y="20213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440752" y="208485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6202" y="2181958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440752" y="2181958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9284" y="420315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443834" y="4209502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95195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58673" y="7943371"/>
            <a:ext cx="620349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Targeted analysis of metabolite profiles.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atmap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representations and hierarchical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luster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nalyses based on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ormalized abundances of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ucleobases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nd nucleosides, (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amino acids and derivatives, (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organic acids and sugars, (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nans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henolics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(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droquinones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(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B vitamins and derivatives and (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nzoxazinoids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For compound labelling see Supplemental Table 7.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Group 16"/>
          <p:cNvGrpSpPr/>
          <p:nvPr/>
        </p:nvGrpSpPr>
        <p:grpSpPr>
          <a:xfrm>
            <a:off x="628967" y="215900"/>
            <a:ext cx="1496378" cy="2865992"/>
            <a:chOff x="4235767" y="281910"/>
            <a:chExt cx="1496378" cy="2865992"/>
          </a:xfrm>
        </p:grpSpPr>
        <p:sp>
          <p:nvSpPr>
            <p:cNvPr id="18" name="TextBox 17"/>
            <p:cNvSpPr txBox="1"/>
            <p:nvPr/>
          </p:nvSpPr>
          <p:spPr>
            <a:xfrm>
              <a:off x="4663197" y="2778790"/>
              <a:ext cx="94769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de-DE" sz="7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de-DE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rm. intensity</a:t>
              </a:r>
              <a:endParaRPr lang="de-D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235767" y="281910"/>
              <a:ext cx="1496378" cy="2531023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235767" y="2944702"/>
              <a:ext cx="1496378" cy="203200"/>
            </a:xfrm>
            <a:prstGeom prst="rect">
              <a:avLst/>
            </a:prstGeom>
          </p:spPr>
        </p:pic>
      </p:grpSp>
      <p:grpSp>
        <p:nvGrpSpPr>
          <p:cNvPr id="21" name="Group 20"/>
          <p:cNvGrpSpPr/>
          <p:nvPr/>
        </p:nvGrpSpPr>
        <p:grpSpPr>
          <a:xfrm>
            <a:off x="2469515" y="141923"/>
            <a:ext cx="1644650" cy="5049378"/>
            <a:chOff x="4274820" y="534353"/>
            <a:chExt cx="1644650" cy="5049378"/>
          </a:xfrm>
        </p:grpSpPr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274820" y="534353"/>
              <a:ext cx="1644650" cy="4682606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274820" y="5363991"/>
              <a:ext cx="1644650" cy="219740"/>
            </a:xfrm>
            <a:prstGeom prst="rect">
              <a:avLst/>
            </a:prstGeom>
          </p:spPr>
        </p:pic>
        <p:sp>
          <p:nvSpPr>
            <p:cNvPr id="24" name="TextBox 23"/>
            <p:cNvSpPr txBox="1"/>
            <p:nvPr/>
          </p:nvSpPr>
          <p:spPr>
            <a:xfrm>
              <a:off x="4788134" y="5200271"/>
              <a:ext cx="94769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de-DE" sz="7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de-DE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rm. intensity</a:t>
              </a:r>
              <a:endParaRPr lang="de-D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4388093" y="221618"/>
            <a:ext cx="1496378" cy="2865992"/>
            <a:chOff x="3988037" y="1073149"/>
            <a:chExt cx="1900090" cy="3471069"/>
          </a:xfrm>
        </p:grpSpPr>
        <p:pic>
          <p:nvPicPr>
            <p:cNvPr id="26" name="Picture 25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988037" y="1073149"/>
              <a:ext cx="1900090" cy="3067761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988037" y="4302055"/>
              <a:ext cx="1900090" cy="242163"/>
            </a:xfrm>
            <a:prstGeom prst="rect">
              <a:avLst/>
            </a:prstGeom>
          </p:spPr>
        </p:pic>
        <p:sp>
          <p:nvSpPr>
            <p:cNvPr id="28" name="TextBox 27"/>
            <p:cNvSpPr txBox="1"/>
            <p:nvPr/>
          </p:nvSpPr>
          <p:spPr>
            <a:xfrm>
              <a:off x="4499957" y="4110148"/>
              <a:ext cx="94769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de-DE" sz="7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de-DE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rm. intensity</a:t>
              </a:r>
              <a:endParaRPr lang="de-D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Group 28"/>
          <p:cNvGrpSpPr/>
          <p:nvPr/>
        </p:nvGrpSpPr>
        <p:grpSpPr>
          <a:xfrm>
            <a:off x="2484842" y="5395483"/>
            <a:ext cx="1560957" cy="2253411"/>
            <a:chOff x="4427115" y="525779"/>
            <a:chExt cx="1836420" cy="2651072"/>
          </a:xfrm>
        </p:grpSpPr>
        <p:sp>
          <p:nvSpPr>
            <p:cNvPr id="30" name="TextBox 29"/>
            <p:cNvSpPr txBox="1"/>
            <p:nvPr/>
          </p:nvSpPr>
          <p:spPr>
            <a:xfrm>
              <a:off x="4978868" y="2744345"/>
              <a:ext cx="94769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de-DE" sz="7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de-DE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rm. intensity</a:t>
              </a:r>
              <a:endParaRPr lang="de-D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1" name="Picture 30"/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427115" y="525779"/>
              <a:ext cx="1836420" cy="2306771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427115" y="2935100"/>
              <a:ext cx="1836420" cy="241751"/>
            </a:xfrm>
            <a:prstGeom prst="rect">
              <a:avLst/>
            </a:prstGeom>
          </p:spPr>
        </p:pic>
      </p:grpSp>
      <p:grpSp>
        <p:nvGrpSpPr>
          <p:cNvPr id="33" name="Group 32"/>
          <p:cNvGrpSpPr/>
          <p:nvPr/>
        </p:nvGrpSpPr>
        <p:grpSpPr>
          <a:xfrm>
            <a:off x="4347353" y="3318836"/>
            <a:ext cx="1577858" cy="1920090"/>
            <a:chOff x="4335580" y="320668"/>
            <a:chExt cx="1577858" cy="1920090"/>
          </a:xfrm>
        </p:grpSpPr>
        <p:pic>
          <p:nvPicPr>
            <p:cNvPr id="34" name="Picture 33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335580" y="320668"/>
              <a:ext cx="1577858" cy="1555750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335580" y="2027300"/>
              <a:ext cx="1577858" cy="213458"/>
            </a:xfrm>
            <a:prstGeom prst="rect">
              <a:avLst/>
            </a:prstGeom>
          </p:spPr>
        </p:pic>
        <p:sp>
          <p:nvSpPr>
            <p:cNvPr id="36" name="TextBox 35"/>
            <p:cNvSpPr txBox="1"/>
            <p:nvPr/>
          </p:nvSpPr>
          <p:spPr>
            <a:xfrm>
              <a:off x="4800041" y="1860166"/>
              <a:ext cx="94769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de-DE" sz="7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de-DE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rm. intensity</a:t>
              </a:r>
              <a:endParaRPr lang="de-D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" name="Group 36"/>
          <p:cNvGrpSpPr/>
          <p:nvPr/>
        </p:nvGrpSpPr>
        <p:grpSpPr>
          <a:xfrm>
            <a:off x="4352254" y="5415927"/>
            <a:ext cx="1544382" cy="1659764"/>
            <a:chOff x="4356356" y="2501900"/>
            <a:chExt cx="1544382" cy="1659764"/>
          </a:xfrm>
        </p:grpSpPr>
        <p:pic>
          <p:nvPicPr>
            <p:cNvPr id="38" name="Picture 37"/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357942" y="2501900"/>
              <a:ext cx="1542796" cy="1310640"/>
            </a:xfrm>
            <a:prstGeom prst="rect">
              <a:avLst/>
            </a:prstGeom>
          </p:spPr>
        </p:pic>
        <p:pic>
          <p:nvPicPr>
            <p:cNvPr id="39" name="Picture 38"/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356356" y="3958751"/>
              <a:ext cx="1542796" cy="202913"/>
            </a:xfrm>
            <a:prstGeom prst="rect">
              <a:avLst/>
            </a:prstGeom>
          </p:spPr>
        </p:pic>
        <p:sp>
          <p:nvSpPr>
            <p:cNvPr id="40" name="TextBox 39"/>
            <p:cNvSpPr txBox="1"/>
            <p:nvPr/>
          </p:nvSpPr>
          <p:spPr>
            <a:xfrm>
              <a:off x="4791158" y="3795852"/>
              <a:ext cx="94769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de-DE" sz="7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de-DE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rm. intensity</a:t>
              </a:r>
              <a:endParaRPr lang="de-D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" name="Group 40"/>
          <p:cNvGrpSpPr/>
          <p:nvPr/>
        </p:nvGrpSpPr>
        <p:grpSpPr>
          <a:xfrm>
            <a:off x="556050" y="3269730"/>
            <a:ext cx="1710416" cy="4410511"/>
            <a:chOff x="4288441" y="542924"/>
            <a:chExt cx="1710416" cy="4410511"/>
          </a:xfrm>
        </p:grpSpPr>
        <p:pic>
          <p:nvPicPr>
            <p:cNvPr id="42" name="Picture 41"/>
            <p:cNvPicPr>
              <a:picLocks noChangeAspect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288441" y="542924"/>
              <a:ext cx="1710416" cy="4038601"/>
            </a:xfrm>
            <a:prstGeom prst="rect">
              <a:avLst/>
            </a:prstGeom>
          </p:spPr>
        </p:pic>
        <p:pic>
          <p:nvPicPr>
            <p:cNvPr id="43" name="Picture 42"/>
            <p:cNvPicPr>
              <a:picLocks noChangeAspect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288441" y="4723293"/>
              <a:ext cx="1710416" cy="230142"/>
            </a:xfrm>
            <a:prstGeom prst="rect">
              <a:avLst/>
            </a:prstGeom>
          </p:spPr>
        </p:pic>
        <p:sp>
          <p:nvSpPr>
            <p:cNvPr id="44" name="TextBox 43"/>
            <p:cNvSpPr txBox="1"/>
            <p:nvPr/>
          </p:nvSpPr>
          <p:spPr>
            <a:xfrm>
              <a:off x="4836322" y="4569051"/>
              <a:ext cx="94769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de-DE" sz="7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de-DE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orm. intensity</a:t>
              </a:r>
              <a:endParaRPr lang="de-D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584423" y="26718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332442" y="26867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238410" y="267186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84423" y="3422187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245038" y="342687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238775" y="5485978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2360226" y="5479628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752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07</Words>
  <Application>Microsoft Office PowerPoint</Application>
  <PresentationFormat>A4 Paper (210x297 mm)</PresentationFormat>
  <Paragraphs>153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tabolite</dc:creator>
  <cp:lastModifiedBy>Metabolite</cp:lastModifiedBy>
  <cp:revision>375</cp:revision>
  <cp:lastPrinted>2020-01-31T13:25:52Z</cp:lastPrinted>
  <dcterms:created xsi:type="dcterms:W3CDTF">2019-02-01T12:40:46Z</dcterms:created>
  <dcterms:modified xsi:type="dcterms:W3CDTF">2020-12-09T10:12:13Z</dcterms:modified>
</cp:coreProperties>
</file>